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5AE8BA-994C-4602-BB9F-826AB0EF8508}" v="3" dt="2024-09-25T03:15:09.61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90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lloom, Ramia J" userId="dee22984-123c-425b-baf5-bc11d491e9e6" providerId="ADAL" clId="{AD5AE8BA-994C-4602-BB9F-826AB0EF8508}"/>
    <pc:docChg chg="modSld">
      <pc:chgData name="Salloom, Ramia J" userId="dee22984-123c-425b-baf5-bc11d491e9e6" providerId="ADAL" clId="{AD5AE8BA-994C-4602-BB9F-826AB0EF8508}" dt="2024-09-25T03:15:31.311" v="242" actId="1035"/>
      <pc:docMkLst>
        <pc:docMk/>
      </pc:docMkLst>
      <pc:sldChg chg="addSp modSp mod">
        <pc:chgData name="Salloom, Ramia J" userId="dee22984-123c-425b-baf5-bc11d491e9e6" providerId="ADAL" clId="{AD5AE8BA-994C-4602-BB9F-826AB0EF8508}" dt="2024-09-25T03:15:31.311" v="242" actId="1035"/>
        <pc:sldMkLst>
          <pc:docMk/>
          <pc:sldMk cId="3221047833" sldId="256"/>
        </pc:sldMkLst>
        <pc:spChg chg="add mod">
          <ac:chgData name="Salloom, Ramia J" userId="dee22984-123c-425b-baf5-bc11d491e9e6" providerId="ADAL" clId="{AD5AE8BA-994C-4602-BB9F-826AB0EF8508}" dt="2024-09-25T03:14:17.213" v="149" actId="1036"/>
          <ac:spMkLst>
            <pc:docMk/>
            <pc:sldMk cId="3221047833" sldId="256"/>
            <ac:spMk id="4" creationId="{ECF78AE4-B9CA-1327-E037-37F690698378}"/>
          </ac:spMkLst>
        </pc:spChg>
        <pc:spChg chg="add mod">
          <ac:chgData name="Salloom, Ramia J" userId="dee22984-123c-425b-baf5-bc11d491e9e6" providerId="ADAL" clId="{AD5AE8BA-994C-4602-BB9F-826AB0EF8508}" dt="2024-09-25T03:14:33.557" v="200" actId="1036"/>
          <ac:spMkLst>
            <pc:docMk/>
            <pc:sldMk cId="3221047833" sldId="256"/>
            <ac:spMk id="6" creationId="{7F57C298-2E65-E78D-F129-BEDA00C961A3}"/>
          </ac:spMkLst>
        </pc:spChg>
        <pc:spChg chg="add mod">
          <ac:chgData name="Salloom, Ramia J" userId="dee22984-123c-425b-baf5-bc11d491e9e6" providerId="ADAL" clId="{AD5AE8BA-994C-4602-BB9F-826AB0EF8508}" dt="2024-09-25T03:14:33.557" v="200" actId="1036"/>
          <ac:spMkLst>
            <pc:docMk/>
            <pc:sldMk cId="3221047833" sldId="256"/>
            <ac:spMk id="8" creationId="{E7159769-4984-3842-8DAA-9EC0E7F2BE36}"/>
          </ac:spMkLst>
        </pc:spChg>
        <pc:spChg chg="mod">
          <ac:chgData name="Salloom, Ramia J" userId="dee22984-123c-425b-baf5-bc11d491e9e6" providerId="ADAL" clId="{AD5AE8BA-994C-4602-BB9F-826AB0EF8508}" dt="2024-09-25T03:14:03.017" v="59" actId="948"/>
          <ac:spMkLst>
            <pc:docMk/>
            <pc:sldMk cId="3221047833" sldId="256"/>
            <ac:spMk id="21" creationId="{27B9C52E-7503-FC2B-F351-CBF9B933E490}"/>
          </ac:spMkLst>
        </pc:spChg>
        <pc:spChg chg="mod">
          <ac:chgData name="Salloom, Ramia J" userId="dee22984-123c-425b-baf5-bc11d491e9e6" providerId="ADAL" clId="{AD5AE8BA-994C-4602-BB9F-826AB0EF8508}" dt="2024-09-25T03:14:03.017" v="59" actId="948"/>
          <ac:spMkLst>
            <pc:docMk/>
            <pc:sldMk cId="3221047833" sldId="256"/>
            <ac:spMk id="22" creationId="{34FB846E-68B4-2E39-3407-40AE63C65179}"/>
          </ac:spMkLst>
        </pc:spChg>
        <pc:spChg chg="mod">
          <ac:chgData name="Salloom, Ramia J" userId="dee22984-123c-425b-baf5-bc11d491e9e6" providerId="ADAL" clId="{AD5AE8BA-994C-4602-BB9F-826AB0EF8508}" dt="2024-09-25T03:14:03.017" v="59" actId="948"/>
          <ac:spMkLst>
            <pc:docMk/>
            <pc:sldMk cId="3221047833" sldId="256"/>
            <ac:spMk id="23" creationId="{E8A0D0D0-904B-259E-3024-DACE81CF4A13}"/>
          </ac:spMkLst>
        </pc:spChg>
        <pc:spChg chg="mod">
          <ac:chgData name="Salloom, Ramia J" userId="dee22984-123c-425b-baf5-bc11d491e9e6" providerId="ADAL" clId="{AD5AE8BA-994C-4602-BB9F-826AB0EF8508}" dt="2024-09-25T03:14:03.017" v="59" actId="948"/>
          <ac:spMkLst>
            <pc:docMk/>
            <pc:sldMk cId="3221047833" sldId="256"/>
            <ac:spMk id="24" creationId="{20926D27-F608-B734-9CDC-05491F866BD8}"/>
          </ac:spMkLst>
        </pc:spChg>
        <pc:spChg chg="mod">
          <ac:chgData name="Salloom, Ramia J" userId="dee22984-123c-425b-baf5-bc11d491e9e6" providerId="ADAL" clId="{AD5AE8BA-994C-4602-BB9F-826AB0EF8508}" dt="2024-09-25T03:14:03.017" v="59" actId="948"/>
          <ac:spMkLst>
            <pc:docMk/>
            <pc:sldMk cId="3221047833" sldId="256"/>
            <ac:spMk id="25" creationId="{1277084B-CC91-9D2D-BF23-357D67CBE5C3}"/>
          </ac:spMkLst>
        </pc:spChg>
        <pc:spChg chg="add mod">
          <ac:chgData name="Salloom, Ramia J" userId="dee22984-123c-425b-baf5-bc11d491e9e6" providerId="ADAL" clId="{AD5AE8BA-994C-4602-BB9F-826AB0EF8508}" dt="2024-09-25T03:14:33.557" v="200" actId="1036"/>
          <ac:spMkLst>
            <pc:docMk/>
            <pc:sldMk cId="3221047833" sldId="256"/>
            <ac:spMk id="26" creationId="{8A3B2168-D52F-C059-A631-F90133962FA6}"/>
          </ac:spMkLst>
        </pc:spChg>
        <pc:spChg chg="add mod">
          <ac:chgData name="Salloom, Ramia J" userId="dee22984-123c-425b-baf5-bc11d491e9e6" providerId="ADAL" clId="{AD5AE8BA-994C-4602-BB9F-826AB0EF8508}" dt="2024-09-25T03:14:33.557" v="200" actId="1036"/>
          <ac:spMkLst>
            <pc:docMk/>
            <pc:sldMk cId="3221047833" sldId="256"/>
            <ac:spMk id="27" creationId="{513BB147-F9E3-A00D-BEA6-A4CB07CD1CC9}"/>
          </ac:spMkLst>
        </pc:spChg>
        <pc:spChg chg="add mod">
          <ac:chgData name="Salloom, Ramia J" userId="dee22984-123c-425b-baf5-bc11d491e9e6" providerId="ADAL" clId="{AD5AE8BA-994C-4602-BB9F-826AB0EF8508}" dt="2024-09-25T03:15:31.311" v="242" actId="1035"/>
          <ac:spMkLst>
            <pc:docMk/>
            <pc:sldMk cId="3221047833" sldId="256"/>
            <ac:spMk id="30" creationId="{83CA06ED-FC05-EB4C-6D01-8DB6DB4F1C4F}"/>
          </ac:spMkLst>
        </pc:spChg>
        <pc:picChg chg="add mod">
          <ac:chgData name="Salloom, Ramia J" userId="dee22984-123c-425b-baf5-bc11d491e9e6" providerId="ADAL" clId="{AD5AE8BA-994C-4602-BB9F-826AB0EF8508}" dt="2024-09-25T03:13:36.718" v="58" actId="14100"/>
          <ac:picMkLst>
            <pc:docMk/>
            <pc:sldMk cId="3221047833" sldId="256"/>
            <ac:picMk id="3" creationId="{AA787D37-6690-C762-C9B5-D7B4B2216F22}"/>
          </ac:picMkLst>
        </pc:picChg>
        <pc:picChg chg="mod">
          <ac:chgData name="Salloom, Ramia J" userId="dee22984-123c-425b-baf5-bc11d491e9e6" providerId="ADAL" clId="{AD5AE8BA-994C-4602-BB9F-826AB0EF8508}" dt="2024-09-25T03:13:27.264" v="53" actId="1038"/>
          <ac:picMkLst>
            <pc:docMk/>
            <pc:sldMk cId="3221047833" sldId="256"/>
            <ac:picMk id="9" creationId="{976C30A5-B638-19A2-DA38-6A62ED8ED37D}"/>
          </ac:picMkLst>
        </pc:picChg>
        <pc:cxnChg chg="add">
          <ac:chgData name="Salloom, Ramia J" userId="dee22984-123c-425b-baf5-bc11d491e9e6" providerId="ADAL" clId="{AD5AE8BA-994C-4602-BB9F-826AB0EF8508}" dt="2024-09-25T03:14:58.501" v="201" actId="11529"/>
          <ac:cxnSpMkLst>
            <pc:docMk/>
            <pc:sldMk cId="3221047833" sldId="256"/>
            <ac:cxnSpMk id="29" creationId="{C5EC5DD1-7D9A-B52D-83FB-7636F58A626D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450AD-B200-19CA-20E0-2E9FF225827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A971A21-F3E4-263A-297A-F5AB64DB834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406A09-92A1-71C0-EF6C-50C1BA79EC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10F4F9-454C-EC83-1D35-4E51C705F6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E72585-2143-F771-C6B0-24B70EA66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99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52A329-DA00-BA27-69DB-68D7EFFC3F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3E2D829-09CC-9D39-D3C9-CD77A09FDF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B28C16-C3AB-C51A-BFCA-DE201A0461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A26D5A-D3A9-412A-C286-FB64C8402C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49053C-961B-044D-ADE1-007F1D48B0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648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9832C2-5718-8DC8-F857-C978B3952F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4A7917-4C2E-5CCB-5FE8-220738FB3C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84986F-DAD8-59E6-DE7A-1F38BD9F1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43B2F-3ED8-0910-8856-6A5FA6ACE5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6ABD8-E4C2-E761-5ED2-AA8C5B2F1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926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E8521-B05A-4D66-8875-7F405EC7FD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F81A57-9DAB-B70E-66E6-C7431CB674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56144B-8773-9AD4-0016-C3D98C645C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D47B5E-7932-9E78-A7F3-9F9D0AF86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A5E2E6-A7D6-6E03-45C2-B7A22D402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989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564196-F580-8389-883D-E41E66D152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4DCB67-0478-A310-A0F9-6F02122A9E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41EFDC-0422-D0FF-88A6-A9B5FDAFA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05661F-0762-598F-571A-63F8C2E4B2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52061B-89F0-2135-3694-9A61B7F05E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9113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680AB1-7461-A92C-568A-001F4954D8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8E32B4-A77E-AB71-28CF-9C5501D260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EF71BE-49D1-8189-5B14-46CF9CB7A3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F20543-7B72-ED5B-3E5F-784A6A5207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5E1CD3-F424-9708-0732-9F3098E235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A65691-E164-2DCE-549D-C3C694D75A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110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1B61B8-98DD-CE42-90B4-CD5A7D2E3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69336A-1E64-8C22-1482-8623DFAC23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C1A4B4-73E7-521A-CEDA-66102AAA7D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38DF30E-3F84-40EE-BC15-623AF74F4E2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A6EAB4-A2AC-6D4F-B01D-58976D52AF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8C2D1D2-0283-9496-3A4F-77DDC8140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EA1234F-C01D-7823-46AC-86180CFAE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858B6D-7578-7987-0AC7-727CA48D89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239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E75380-F8EF-EE02-B384-B8FFBEDA7B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65F7C3-4F7F-8572-39D1-222E46751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F4C8881-0CD3-0DF1-B5EA-F0CC51419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55FCFF-BFFC-028D-75B2-DC425BEE58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592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7609218-04B4-E60B-70D8-A90A9FA2F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60C8836-9C58-C6BB-5FA9-9913C6EBA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DFBCDF8-59EC-BF03-BFD5-C30CA0CE2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549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930511-283B-0FFD-24EE-5971AC4A5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F9E680-8206-558A-8155-26736D7816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DF425D-AEC4-B01F-6647-386642A623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4D2E27-D030-1D8D-B40F-C945A4B3BA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FC3221-A145-FE48-06B9-5F4495FB9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FB9F87-F0D0-C3A6-D598-C052DFA36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818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F6327F-7CE5-019A-8785-99B3BDD99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9B5741-1E73-0D92-A306-7AF5B3A784A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E27808-094D-2A56-C6FB-2E7A6909A4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A43D8C-B85B-8A4D-A20F-2E68FFF83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8AB100-9A16-CE21-75A6-4EEC016F8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47F1BC-FFA9-FDAB-AD88-6B1B9CFB06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0111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03AACC-E54F-CBA2-D4BF-58CA973154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80E7D7-0FA4-A9F4-80D3-AC481115C8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CAB0D2-749C-8211-E23C-A2C9C4A1FE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84844EF-4294-4745-AB34-28DFAD24D4AD}" type="datetimeFigureOut">
              <a:rPr lang="en-US" smtClean="0"/>
              <a:t>9/24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34129C-F8F2-5C3E-4EB1-2EF34C34F2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67BE76-002E-F015-0B92-E7EE619C4E2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BFD83C-4AA0-4C08-81A6-6D5CFF35DB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639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urry image of a person walking&#10;&#10;Description automatically generated">
            <a:extLst>
              <a:ext uri="{FF2B5EF4-FFF2-40B4-BE49-F238E27FC236}">
                <a16:creationId xmlns:a16="http://schemas.microsoft.com/office/drawing/2014/main" id="{C9A6FE3A-8FCE-7543-3C10-1DF6378161A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4943" y="1470152"/>
            <a:ext cx="3812261" cy="1306576"/>
          </a:xfrm>
          <a:prstGeom prst="rect">
            <a:avLst/>
          </a:prstGeom>
        </p:spPr>
      </p:pic>
      <p:pic>
        <p:nvPicPr>
          <p:cNvPr id="5" name="Picture 4" descr="A close-up of a test strip&#10;&#10;Description automatically generated">
            <a:extLst>
              <a:ext uri="{FF2B5EF4-FFF2-40B4-BE49-F238E27FC236}">
                <a16:creationId xmlns:a16="http://schemas.microsoft.com/office/drawing/2014/main" id="{46D0553E-BE6E-73D2-5A3C-543A1F588F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1596" y="4153916"/>
            <a:ext cx="3352134" cy="2226564"/>
          </a:xfrm>
          <a:prstGeom prst="rect">
            <a:avLst/>
          </a:prstGeom>
        </p:spPr>
      </p:pic>
      <p:pic>
        <p:nvPicPr>
          <p:cNvPr id="7" name="Picture 6" descr="A close-up of a test&#10;&#10;Description automatically generated">
            <a:extLst>
              <a:ext uri="{FF2B5EF4-FFF2-40B4-BE49-F238E27FC236}">
                <a16:creationId xmlns:a16="http://schemas.microsoft.com/office/drawing/2014/main" id="{CE97EC01-C271-24EE-45D1-4E9D140FF8F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7808" y="961136"/>
            <a:ext cx="3202432" cy="210698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4063C8A0-6DAF-85F6-22A5-74F6D78F83FD}"/>
              </a:ext>
            </a:extLst>
          </p:cNvPr>
          <p:cNvSpPr txBox="1"/>
          <p:nvPr/>
        </p:nvSpPr>
        <p:spPr>
          <a:xfrm>
            <a:off x="3027680" y="745692"/>
            <a:ext cx="1676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ontrol   +Do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C81DAB3-789C-E1C9-78C9-A903C1447ED9}"/>
              </a:ext>
            </a:extLst>
          </p:cNvPr>
          <p:cNvSpPr txBox="1"/>
          <p:nvPr/>
        </p:nvSpPr>
        <p:spPr>
          <a:xfrm>
            <a:off x="8280400" y="1192732"/>
            <a:ext cx="1676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ontrol   +Do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75C8D9D-0CC5-3A9D-FB51-80BBE425979D}"/>
              </a:ext>
            </a:extLst>
          </p:cNvPr>
          <p:cNvSpPr txBox="1"/>
          <p:nvPr/>
        </p:nvSpPr>
        <p:spPr>
          <a:xfrm>
            <a:off x="6573520" y="3925772"/>
            <a:ext cx="1676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ontrol   +Do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741468F-C6EE-9FD6-8295-2772A66E7A7F}"/>
              </a:ext>
            </a:extLst>
          </p:cNvPr>
          <p:cNvSpPr txBox="1"/>
          <p:nvPr/>
        </p:nvSpPr>
        <p:spPr>
          <a:xfrm>
            <a:off x="4441026" y="1928614"/>
            <a:ext cx="806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O-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F2A6CF7-3DD3-E6E3-0A1B-8AE6878C6BD4}"/>
              </a:ext>
            </a:extLst>
          </p:cNvPr>
          <p:cNvSpPr txBox="1"/>
          <p:nvPr/>
        </p:nvSpPr>
        <p:spPr>
          <a:xfrm>
            <a:off x="9813624" y="1465960"/>
            <a:ext cx="806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O-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CFD5A3-F90D-4381-462A-CFDE81165146}"/>
              </a:ext>
            </a:extLst>
          </p:cNvPr>
          <p:cNvSpPr txBox="1"/>
          <p:nvPr/>
        </p:nvSpPr>
        <p:spPr>
          <a:xfrm>
            <a:off x="8001117" y="4888400"/>
            <a:ext cx="898711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1" dirty="0"/>
              <a:t>β-Acti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68B1827-262D-D7EB-A464-7005FA50E66E}"/>
              </a:ext>
            </a:extLst>
          </p:cNvPr>
          <p:cNvSpPr txBox="1"/>
          <p:nvPr/>
        </p:nvSpPr>
        <p:spPr>
          <a:xfrm>
            <a:off x="4409440" y="274320"/>
            <a:ext cx="2861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M-1 parent +Doc</a:t>
            </a:r>
          </a:p>
        </p:txBody>
      </p:sp>
    </p:spTree>
    <p:extLst>
      <p:ext uri="{BB962C8B-B14F-4D97-AF65-F5344CB8AC3E}">
        <p14:creationId xmlns:p14="http://schemas.microsoft.com/office/powerpoint/2010/main" val="8505157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white background with black spots&#10;&#10;Description automatically generated">
            <a:extLst>
              <a:ext uri="{FF2B5EF4-FFF2-40B4-BE49-F238E27FC236}">
                <a16:creationId xmlns:a16="http://schemas.microsoft.com/office/drawing/2014/main" id="{E048683A-68B6-A19B-0D4F-B43B29B08C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583" y="1220470"/>
            <a:ext cx="3649369" cy="2360421"/>
          </a:xfrm>
          <a:prstGeom prst="rect">
            <a:avLst/>
          </a:prstGeom>
        </p:spPr>
      </p:pic>
      <p:pic>
        <p:nvPicPr>
          <p:cNvPr id="7" name="Picture 6" descr="A close-up of a smoke&#10;&#10;Description automatically generated">
            <a:extLst>
              <a:ext uri="{FF2B5EF4-FFF2-40B4-BE49-F238E27FC236}">
                <a16:creationId xmlns:a16="http://schemas.microsoft.com/office/drawing/2014/main" id="{BDE5A052-7B6B-35A3-7D65-29DEF8DE54F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0727" y="1202154"/>
            <a:ext cx="3441193" cy="2356912"/>
          </a:xfrm>
          <a:prstGeom prst="rect">
            <a:avLst/>
          </a:prstGeom>
        </p:spPr>
      </p:pic>
      <p:pic>
        <p:nvPicPr>
          <p:cNvPr id="9" name="Picture 8" descr="A close up of a black line&#10;&#10;Description automatically generated">
            <a:extLst>
              <a:ext uri="{FF2B5EF4-FFF2-40B4-BE49-F238E27FC236}">
                <a16:creationId xmlns:a16="http://schemas.microsoft.com/office/drawing/2014/main" id="{976C30A5-B638-19A2-DA38-6A62ED8ED37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73520" y="4147639"/>
            <a:ext cx="1940560" cy="270249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6A6AC11-F417-54BC-8E40-E8F31184801A}"/>
              </a:ext>
            </a:extLst>
          </p:cNvPr>
          <p:cNvSpPr txBox="1"/>
          <p:nvPr/>
        </p:nvSpPr>
        <p:spPr>
          <a:xfrm>
            <a:off x="4409440" y="274320"/>
            <a:ext cx="2861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M-1 parent and RM-1 K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58544AD-F5CD-6E17-1FB2-A4FE2DE9A343}"/>
              </a:ext>
            </a:extLst>
          </p:cNvPr>
          <p:cNvSpPr txBox="1"/>
          <p:nvPr/>
        </p:nvSpPr>
        <p:spPr>
          <a:xfrm>
            <a:off x="4184984" y="2441320"/>
            <a:ext cx="806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O-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677021B-7B99-A96F-42F3-83E4CEBA86D4}"/>
              </a:ext>
            </a:extLst>
          </p:cNvPr>
          <p:cNvSpPr txBox="1"/>
          <p:nvPr/>
        </p:nvSpPr>
        <p:spPr>
          <a:xfrm>
            <a:off x="650240" y="904240"/>
            <a:ext cx="497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</a:t>
            </a:r>
          </a:p>
          <a:p>
            <a:pPr algn="ctr"/>
            <a:r>
              <a:rPr lang="en-US" sz="800" dirty="0"/>
              <a:t>paren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7E046A-B780-A5D4-2C3C-573026F6977A}"/>
              </a:ext>
            </a:extLst>
          </p:cNvPr>
          <p:cNvSpPr txBox="1"/>
          <p:nvPr/>
        </p:nvSpPr>
        <p:spPr>
          <a:xfrm>
            <a:off x="941136" y="768965"/>
            <a:ext cx="6699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parent</a:t>
            </a:r>
          </a:p>
          <a:p>
            <a:pPr algn="ctr"/>
            <a:r>
              <a:rPr lang="en-US" sz="800" dirty="0"/>
              <a:t>+</a:t>
            </a:r>
            <a:r>
              <a:rPr lang="en-US" sz="800" dirty="0" err="1"/>
              <a:t>CoPP</a:t>
            </a:r>
            <a:endParaRPr lang="en-US" sz="8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DC35CAF-A527-F9EA-87D3-DE50D2CAB423}"/>
              </a:ext>
            </a:extLst>
          </p:cNvPr>
          <p:cNvSpPr txBox="1"/>
          <p:nvPr/>
        </p:nvSpPr>
        <p:spPr>
          <a:xfrm>
            <a:off x="1391920" y="863600"/>
            <a:ext cx="497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K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F3E3661-FB68-4FC2-969E-2C613D1DFAF7}"/>
              </a:ext>
            </a:extLst>
          </p:cNvPr>
          <p:cNvSpPr txBox="1"/>
          <p:nvPr/>
        </p:nvSpPr>
        <p:spPr>
          <a:xfrm>
            <a:off x="1767840" y="782320"/>
            <a:ext cx="4978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KO +</a:t>
            </a:r>
            <a:r>
              <a:rPr lang="en-US" sz="800" dirty="0" err="1"/>
              <a:t>CoPP</a:t>
            </a:r>
            <a:endParaRPr lang="en-US" sz="8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409F2EF-6CA2-0511-BE94-C99464005A1F}"/>
              </a:ext>
            </a:extLst>
          </p:cNvPr>
          <p:cNvSpPr txBox="1"/>
          <p:nvPr/>
        </p:nvSpPr>
        <p:spPr>
          <a:xfrm>
            <a:off x="5699760" y="853440"/>
            <a:ext cx="497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</a:t>
            </a:r>
          </a:p>
          <a:p>
            <a:pPr algn="ctr"/>
            <a:r>
              <a:rPr lang="en-US" sz="800" dirty="0"/>
              <a:t>paren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D29AAF0-2A24-AE41-0CC0-0BF400D5E599}"/>
              </a:ext>
            </a:extLst>
          </p:cNvPr>
          <p:cNvSpPr txBox="1"/>
          <p:nvPr/>
        </p:nvSpPr>
        <p:spPr>
          <a:xfrm>
            <a:off x="5990656" y="718165"/>
            <a:ext cx="6699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parent</a:t>
            </a:r>
          </a:p>
          <a:p>
            <a:pPr algn="ctr"/>
            <a:r>
              <a:rPr lang="en-US" sz="800" dirty="0"/>
              <a:t>+</a:t>
            </a:r>
            <a:r>
              <a:rPr lang="en-US" sz="800" dirty="0" err="1"/>
              <a:t>CoPP</a:t>
            </a:r>
            <a:endParaRPr lang="en-US" sz="8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C7EDE49-8FC8-E2D9-3A85-909E2A13252E}"/>
              </a:ext>
            </a:extLst>
          </p:cNvPr>
          <p:cNvSpPr txBox="1"/>
          <p:nvPr/>
        </p:nvSpPr>
        <p:spPr>
          <a:xfrm>
            <a:off x="6441440" y="812800"/>
            <a:ext cx="497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K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D3F5F99-3F52-E696-6011-2402F40EEF2C}"/>
              </a:ext>
            </a:extLst>
          </p:cNvPr>
          <p:cNvSpPr txBox="1"/>
          <p:nvPr/>
        </p:nvSpPr>
        <p:spPr>
          <a:xfrm>
            <a:off x="6817360" y="731520"/>
            <a:ext cx="4978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KO +</a:t>
            </a:r>
            <a:r>
              <a:rPr lang="en-US" sz="800" dirty="0" err="1"/>
              <a:t>CoPP</a:t>
            </a:r>
            <a:endParaRPr lang="en-US" sz="8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A1DD540-71DB-FDA3-85F7-C0CB8A7069CD}"/>
              </a:ext>
            </a:extLst>
          </p:cNvPr>
          <p:cNvSpPr txBox="1"/>
          <p:nvPr/>
        </p:nvSpPr>
        <p:spPr>
          <a:xfrm>
            <a:off x="8939864" y="2268600"/>
            <a:ext cx="806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O-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7B9C52E-7503-FC2B-F351-CBF9B933E490}"/>
              </a:ext>
            </a:extLst>
          </p:cNvPr>
          <p:cNvSpPr txBox="1"/>
          <p:nvPr/>
        </p:nvSpPr>
        <p:spPr>
          <a:xfrm>
            <a:off x="8664008" y="5403431"/>
            <a:ext cx="1053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4FB846E-68B4-2E39-3407-40AE63C65179}"/>
              </a:ext>
            </a:extLst>
          </p:cNvPr>
          <p:cNvSpPr txBox="1"/>
          <p:nvPr/>
        </p:nvSpPr>
        <p:spPr>
          <a:xfrm>
            <a:off x="6837680" y="3799840"/>
            <a:ext cx="497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</a:t>
            </a:r>
          </a:p>
          <a:p>
            <a:pPr algn="ctr"/>
            <a:r>
              <a:rPr lang="en-US" sz="800" dirty="0"/>
              <a:t>paren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8A0D0D0-904B-259E-3024-DACE81CF4A13}"/>
              </a:ext>
            </a:extLst>
          </p:cNvPr>
          <p:cNvSpPr txBox="1"/>
          <p:nvPr/>
        </p:nvSpPr>
        <p:spPr>
          <a:xfrm>
            <a:off x="7128576" y="3664565"/>
            <a:ext cx="6699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parent</a:t>
            </a:r>
          </a:p>
          <a:p>
            <a:pPr algn="ctr"/>
            <a:r>
              <a:rPr lang="en-US" sz="800" dirty="0"/>
              <a:t>+</a:t>
            </a:r>
            <a:r>
              <a:rPr lang="en-US" sz="800" dirty="0" err="1"/>
              <a:t>CoPP</a:t>
            </a:r>
            <a:endParaRPr lang="en-US" sz="8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0926D27-F608-B734-9CDC-05491F866BD8}"/>
              </a:ext>
            </a:extLst>
          </p:cNvPr>
          <p:cNvSpPr txBox="1"/>
          <p:nvPr/>
        </p:nvSpPr>
        <p:spPr>
          <a:xfrm>
            <a:off x="7579360" y="3759200"/>
            <a:ext cx="497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K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277084B-CC91-9D2D-BF23-357D67CBE5C3}"/>
              </a:ext>
            </a:extLst>
          </p:cNvPr>
          <p:cNvSpPr txBox="1"/>
          <p:nvPr/>
        </p:nvSpPr>
        <p:spPr>
          <a:xfrm>
            <a:off x="7955280" y="3677920"/>
            <a:ext cx="4978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KO +</a:t>
            </a:r>
            <a:r>
              <a:rPr lang="en-US" sz="800" dirty="0" err="1"/>
              <a:t>CoPP</a:t>
            </a:r>
            <a:endParaRPr lang="en-US" sz="800" dirty="0"/>
          </a:p>
        </p:txBody>
      </p:sp>
      <p:pic>
        <p:nvPicPr>
          <p:cNvPr id="3" name="Picture 2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AA787D37-6690-C762-C9B5-D7B4B2216F2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7836" y="4269993"/>
            <a:ext cx="3649368" cy="237396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CF78AE4-B9CA-1327-E037-37F690698378}"/>
              </a:ext>
            </a:extLst>
          </p:cNvPr>
          <p:cNvSpPr txBox="1"/>
          <p:nvPr/>
        </p:nvSpPr>
        <p:spPr>
          <a:xfrm>
            <a:off x="4914968" y="5332311"/>
            <a:ext cx="1053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F57C298-2E65-E78D-F129-BEDA00C961A3}"/>
              </a:ext>
            </a:extLst>
          </p:cNvPr>
          <p:cNvSpPr txBox="1"/>
          <p:nvPr/>
        </p:nvSpPr>
        <p:spPr>
          <a:xfrm>
            <a:off x="1310640" y="3870960"/>
            <a:ext cx="497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</a:t>
            </a:r>
          </a:p>
          <a:p>
            <a:pPr algn="ctr"/>
            <a:r>
              <a:rPr lang="en-US" sz="800" dirty="0"/>
              <a:t>paren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159769-4984-3842-8DAA-9EC0E7F2BE36}"/>
              </a:ext>
            </a:extLst>
          </p:cNvPr>
          <p:cNvSpPr txBox="1"/>
          <p:nvPr/>
        </p:nvSpPr>
        <p:spPr>
          <a:xfrm>
            <a:off x="1601536" y="3735685"/>
            <a:ext cx="6699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parent</a:t>
            </a:r>
          </a:p>
          <a:p>
            <a:pPr algn="ctr"/>
            <a:r>
              <a:rPr lang="en-US" sz="800" dirty="0"/>
              <a:t>+</a:t>
            </a:r>
            <a:r>
              <a:rPr lang="en-US" sz="800" dirty="0" err="1"/>
              <a:t>CoPP</a:t>
            </a:r>
            <a:endParaRPr lang="en-US" sz="8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A3B2168-D52F-C059-A631-F90133962FA6}"/>
              </a:ext>
            </a:extLst>
          </p:cNvPr>
          <p:cNvSpPr txBox="1"/>
          <p:nvPr/>
        </p:nvSpPr>
        <p:spPr>
          <a:xfrm>
            <a:off x="2052320" y="3830320"/>
            <a:ext cx="4978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KO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13BB147-F9E3-A00D-BEA6-A4CB07CD1CC9}"/>
              </a:ext>
            </a:extLst>
          </p:cNvPr>
          <p:cNvSpPr txBox="1"/>
          <p:nvPr/>
        </p:nvSpPr>
        <p:spPr>
          <a:xfrm>
            <a:off x="2428240" y="3749040"/>
            <a:ext cx="4978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/>
              <a:t>RM-1 KO +</a:t>
            </a:r>
            <a:r>
              <a:rPr lang="en-US" sz="800" dirty="0" err="1"/>
              <a:t>CoPP</a:t>
            </a:r>
            <a:endParaRPr lang="en-US" sz="800" dirty="0"/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C5EC5DD1-7D9A-B52D-83FB-7636F58A626D}"/>
              </a:ext>
            </a:extLst>
          </p:cNvPr>
          <p:cNvCxnSpPr/>
          <p:nvPr/>
        </p:nvCxnSpPr>
        <p:spPr>
          <a:xfrm>
            <a:off x="4914968" y="4775200"/>
            <a:ext cx="1658552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83CA06ED-FC05-EB4C-6D01-8DB6DB4F1C4F}"/>
              </a:ext>
            </a:extLst>
          </p:cNvPr>
          <p:cNvSpPr txBox="1"/>
          <p:nvPr/>
        </p:nvSpPr>
        <p:spPr>
          <a:xfrm>
            <a:off x="4991229" y="4257040"/>
            <a:ext cx="145021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Zoomed in on the left section</a:t>
            </a:r>
          </a:p>
        </p:txBody>
      </p:sp>
    </p:spTree>
    <p:extLst>
      <p:ext uri="{BB962C8B-B14F-4D97-AF65-F5344CB8AC3E}">
        <p14:creationId xmlns:p14="http://schemas.microsoft.com/office/powerpoint/2010/main" val="3221047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84a28940-b464-41c3-ba3b-b4fa6665bc05}" enabled="0" method="" siteId="{84a28940-b464-41c3-ba3b-b4fa6665bc05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79</Words>
  <Application>Microsoft Office PowerPoint</Application>
  <PresentationFormat>Widescreen</PresentationFormat>
  <Paragraphs>3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lloom, Ramia J</dc:creator>
  <cp:lastModifiedBy>Salloom, Ramia J</cp:lastModifiedBy>
  <cp:revision>2</cp:revision>
  <dcterms:created xsi:type="dcterms:W3CDTF">2024-08-26T03:06:43Z</dcterms:created>
  <dcterms:modified xsi:type="dcterms:W3CDTF">2024-09-25T03:15:35Z</dcterms:modified>
</cp:coreProperties>
</file>